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D8B0F5-87AA-4031-9485-34ECDD27D43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A6A075-2237-4007-B444-7E7FEC2094F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1D92B9-DE61-4FCB-BA68-3FFAEA9E692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107B04-02F8-4136-B080-A60024702C6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E9379A-89E4-48DF-B871-2D91729CD3A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FF4ED6-F3D3-4EAA-A01D-E1659D1EF5C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D1A4FA-1C61-424A-BCBA-9CC04C6A50E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555B48-F576-4460-8C5F-9F64F35E18B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E0F891-D83D-4C57-802E-F61CBB03885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DC80BC-A718-4A81-BFAD-4999FEF491D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86221D-0B81-4219-A547-9D23AA92DA2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293342-2822-408C-A057-5EAA8A98A7E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noFill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8B2E67F-750D-4C5D-A00F-A92A25D47EBC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2"/>
          <p:cNvSpPr/>
          <p:nvPr/>
        </p:nvSpPr>
        <p:spPr>
          <a:xfrm>
            <a:off x="1143000" y="762120"/>
            <a:ext cx="7848720" cy="5115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ourier New"/>
              </a:rPr>
              <a:t>OmpL37:   8   ILIVIILVFGEL--LWAVSPDQINLGILIGENKTNLKFINICVSNLAPILEPTNSDTSPP 65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ourier New"/>
              </a:rPr>
              <a:t>               </a:t>
            </a:r>
            <a:r>
              <a:rPr b="0" lang="en-US" sz="1100" spc="-1" strike="noStrike">
                <a:solidFill>
                  <a:srgbClr val="000000"/>
                </a:solidFill>
                <a:latin typeface="Courier New"/>
              </a:rPr>
              <a:t>++   +V G +  +</a:t>
            </a:r>
            <a:r>
              <a:rPr b="0" lang="en-US" sz="200" spc="-1" strike="noStrike">
                <a:solidFill>
                  <a:srgbClr val="000000"/>
                </a:solidFill>
                <a:latin typeface="Courier New"/>
              </a:rPr>
              <a:t>    </a:t>
            </a:r>
            <a:r>
              <a:rPr b="0" lang="en-US" sz="1100" spc="-1" strike="noStrike">
                <a:solidFill>
                  <a:srgbClr val="000000"/>
                </a:solidFill>
                <a:latin typeface="Courier New"/>
              </a:rPr>
              <a:t>AVSP+Q NLGILI</a:t>
            </a:r>
            <a:r>
              <a:rPr b="0" lang="en-US" sz="200" spc="-1" strike="noStrike">
                <a:solidFill>
                  <a:srgbClr val="000000"/>
                </a:solidFill>
                <a:latin typeface="Courier New"/>
              </a:rPr>
              <a:t>    </a:t>
            </a:r>
            <a:r>
              <a:rPr b="0" lang="en-US" sz="1100" spc="-1" strike="noStrike">
                <a:solidFill>
                  <a:srgbClr val="000000"/>
                </a:solidFill>
                <a:latin typeface="Courier New"/>
              </a:rPr>
              <a:t>ENK NL FIN+ +SNLAP  E   +   P 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ourier New"/>
              </a:rPr>
              <a:t>LBF 0995: 6   FILFFAMVVGHISHINAVSPEQTNLGILIFENKENLNFINVALSNLAPSQEEAQTTAQPG 65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ourier New"/>
              </a:rPr>
              <a:t>OmpL37:   66  NNTKVEAGNTTTEVGDKVELFKKLGALPSYISLKKANQFDFNGNMLYFQSNYSLSFKNLR 125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ourier New"/>
              </a:rPr>
              <a:t>                </a:t>
            </a:r>
            <a:r>
              <a:rPr b="0" lang="en-US" sz="1100" spc="-1" strike="noStrike">
                <a:solidFill>
                  <a:srgbClr val="000000"/>
                </a:solidFill>
                <a:latin typeface="Courier New"/>
              </a:rPr>
              <a:t>T  +  +    </a:t>
            </a:r>
            <a:r>
              <a:rPr b="0" lang="en-US" sz="200" spc="-1" strike="noStrike">
                <a:solidFill>
                  <a:srgbClr val="000000"/>
                </a:solidFill>
                <a:latin typeface="Courier New"/>
              </a:rPr>
              <a:t>    </a:t>
            </a:r>
            <a:r>
              <a:rPr b="0" lang="en-US" sz="1100" spc="-1" strike="noStrike">
                <a:solidFill>
                  <a:srgbClr val="000000"/>
                </a:solidFill>
                <a:latin typeface="Courier New"/>
              </a:rPr>
              <a:t> D  +L            LK ANQ</a:t>
            </a:r>
            <a:r>
              <a:rPr b="0" lang="en-US" sz="200" spc="-1" strike="noStrike">
                <a:solidFill>
                  <a:srgbClr val="000000"/>
                </a:solidFill>
                <a:latin typeface="Courier New"/>
              </a:rPr>
              <a:t>    </a:t>
            </a:r>
            <a:r>
              <a:rPr b="0" lang="en-US" sz="1100" spc="-1" strike="noStrike">
                <a:solidFill>
                  <a:srgbClr val="000000"/>
                </a:solidFill>
                <a:latin typeface="Courier New"/>
              </a:rPr>
              <a:t>DF+GNM Y QSNY   F+ LR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ourier New"/>
              </a:rPr>
              <a:t>LBF 0995: 66  AETPPQDPSKKNLDFDYFKL------------LKAANQSDFSGNMWYLQSNYVYGFRQLR 113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ourier New"/>
              </a:rPr>
              <a:t>OmpL37:   126 GAQGEMKDLYQATHEQYLQNSRILLEYASPLIVRSNDKIAQHLLRLGFRDLKSSEDHFTI 185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ourier New"/>
              </a:rPr>
              <a:t>               </a:t>
            </a:r>
            <a:r>
              <a:rPr b="0" lang="en-US" sz="1100" spc="-1" strike="noStrike">
                <a:solidFill>
                  <a:srgbClr val="000000"/>
                </a:solidFill>
                <a:latin typeface="Courier New"/>
              </a:rPr>
              <a:t>AQGE+K++++  </a:t>
            </a:r>
            <a:r>
              <a:rPr b="0" lang="en-US" sz="200" spc="-1" strike="noStrike">
                <a:solidFill>
                  <a:srgbClr val="000000"/>
                </a:solidFill>
                <a:latin typeface="Courier New"/>
              </a:rPr>
              <a:t>     </a:t>
            </a:r>
            <a:r>
              <a:rPr b="0" lang="en-US" sz="1100" spc="-1" strike="noStrike">
                <a:solidFill>
                  <a:srgbClr val="000000"/>
                </a:solidFill>
                <a:latin typeface="Courier New"/>
              </a:rPr>
              <a:t>++Y++++R</a:t>
            </a:r>
            <a:r>
              <a:rPr b="0" lang="en-US" sz="200" spc="-1" strike="noStrike">
                <a:solidFill>
                  <a:srgbClr val="000000"/>
                </a:solidFill>
                <a:latin typeface="Courier New"/>
              </a:rPr>
              <a:t>    </a:t>
            </a:r>
            <a:r>
              <a:rPr b="0" lang="en-US" sz="1100" spc="-1" strike="noStrike">
                <a:solidFill>
                  <a:srgbClr val="000000"/>
                </a:solidFill>
                <a:latin typeface="Courier New"/>
              </a:rPr>
              <a:t>LLE A+P I+RSND  A+</a:t>
            </a:r>
            <a:r>
              <a:rPr b="0" lang="en-US" sz="200" spc="-1" strike="noStrike">
                <a:solidFill>
                  <a:srgbClr val="000000"/>
                </a:solidFill>
                <a:latin typeface="Courier New"/>
              </a:rPr>
              <a:t>    </a:t>
            </a:r>
            <a:r>
              <a:rPr b="0" lang="en-US" sz="1100" spc="-1" strike="noStrike">
                <a:solidFill>
                  <a:srgbClr val="000000"/>
                </a:solidFill>
                <a:latin typeface="Courier New"/>
              </a:rPr>
              <a:t>LLRLGFRDL+SSED +T 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ourier New"/>
              </a:rPr>
              <a:t>LBF 0995: 114 QAQGELKNIFEIVLQKYIEDARALLEAAAPTIIRSNDSNAKALLRLGFRDLRSSEDLYTT 173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ourier New"/>
              </a:rPr>
              <a:t>OmpL37:   186 AYNSAPYQFRYKLLLHGEGIKIARRARKFALLAMIASKTPTEDKPEYQFVNLDDMRAAVE 245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ourier New"/>
              </a:rPr>
              <a:t>                </a:t>
            </a:r>
            <a:r>
              <a:rPr b="0" lang="en-US" sz="1100" spc="-1" strike="noStrike">
                <a:solidFill>
                  <a:srgbClr val="000000"/>
                </a:solidFill>
                <a:latin typeface="Courier New"/>
              </a:rPr>
              <a:t>NS+P+Q+RYKL L+</a:t>
            </a:r>
            <a:r>
              <a:rPr b="0" lang="en-US" sz="200" spc="-1" strike="noStrike">
                <a:solidFill>
                  <a:srgbClr val="000000"/>
                </a:solidFill>
                <a:latin typeface="Courier New"/>
              </a:rPr>
              <a:t>    </a:t>
            </a:r>
            <a:r>
              <a:rPr b="0" lang="en-US" sz="1100" spc="-1" strike="noStrike">
                <a:solidFill>
                  <a:srgbClr val="000000"/>
                </a:solidFill>
                <a:latin typeface="Courier New"/>
              </a:rPr>
              <a:t>EGI   RRA++FA+LAMI</a:t>
            </a:r>
            <a:r>
              <a:rPr b="0" lang="en-US" sz="200" spc="-1" strike="noStrike">
                <a:solidFill>
                  <a:srgbClr val="000000"/>
                </a:solidFill>
                <a:latin typeface="Courier New"/>
              </a:rPr>
              <a:t>    </a:t>
            </a:r>
            <a:r>
              <a:rPr b="0" lang="en-US" sz="1100" spc="-1" strike="noStrike">
                <a:solidFill>
                  <a:srgbClr val="000000"/>
                </a:solidFill>
                <a:latin typeface="Courier New"/>
              </a:rPr>
              <a:t>SKTP EDKPEYQ+ + +D++ A  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ourier New"/>
              </a:rPr>
              <a:t>LBF 0995: 174 GLNSSPHQYRYKLTLYKEGILTLRRAKRFAILAMIYSKTPDEDKPEYQYRSNEDLKEARN 233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ourier New"/>
              </a:rPr>
              <a:t>OmpL37:   246 KETITDYEKVRNTLINYIDNDLLQRKIVPPGEAKDKPIDILEIHDDNYGIITSGRISMMD 305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ourier New"/>
              </a:rPr>
              <a:t>              </a:t>
            </a:r>
            <a:r>
              <a:rPr b="0" lang="en-US" sz="1100" spc="-1" strike="noStrike">
                <a:solidFill>
                  <a:srgbClr val="000000"/>
                </a:solidFill>
                <a:latin typeface="Courier New"/>
              </a:rPr>
              <a:t>+E  </a:t>
            </a:r>
            <a:r>
              <a:rPr b="0" lang="en-US" sz="200" spc="-1" strike="noStrike">
                <a:solidFill>
                  <a:srgbClr val="000000"/>
                </a:solidFill>
                <a:latin typeface="Courier New"/>
              </a:rPr>
              <a:t>     </a:t>
            </a:r>
            <a:r>
              <a:rPr b="0" lang="en-US" sz="1100" spc="-1" strike="noStrike">
                <a:solidFill>
                  <a:srgbClr val="000000"/>
                </a:solidFill>
                <a:latin typeface="Courier New"/>
              </a:rPr>
              <a:t>+YEKVR+TLIN+I+N</a:t>
            </a:r>
            <a:r>
              <a:rPr b="0" lang="en-US" sz="200" spc="-1" strike="noStrike">
                <a:solidFill>
                  <a:srgbClr val="000000"/>
                </a:solidFill>
                <a:latin typeface="Courier New"/>
              </a:rPr>
              <a:t>          </a:t>
            </a:r>
            <a:r>
              <a:rPr b="0" lang="en-US" sz="1100" spc="-1" strike="noStrike">
                <a:solidFill>
                  <a:srgbClr val="000000"/>
                </a:solidFill>
                <a:latin typeface="Courier New"/>
              </a:rPr>
              <a:t>++R +VPPG  </a:t>
            </a:r>
            <a:r>
              <a:rPr b="0" lang="en-US" sz="200" spc="-1" strike="noStrike">
                <a:solidFill>
                  <a:srgbClr val="000000"/>
                </a:solidFill>
                <a:latin typeface="Courier New"/>
              </a:rPr>
              <a:t>    </a:t>
            </a:r>
            <a:r>
              <a:rPr b="0" lang="en-US" sz="1100" spc="-1" strike="noStrike">
                <a:solidFill>
                  <a:srgbClr val="000000"/>
                </a:solidFill>
                <a:latin typeface="Courier New"/>
              </a:rPr>
              <a:t> KP+D+LE HDDNYG ITS ++ ++ 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ourier New"/>
              </a:rPr>
              <a:t>LBF 0995: 234 EEKQRNYEKVRDTLINFIENKRMERTVVPPGNPDAKPLDLLEQHDDNYGFITSKKLDLLL 293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ourier New"/>
              </a:rPr>
              <a:t>OmpL37:   306 MSNEEIKTSDAIQKETLPPIPTKTQN 331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100" spc="-1" strike="noStrike">
                <a:solidFill>
                  <a:srgbClr val="000000"/>
                </a:solidFill>
                <a:latin typeface="Courier New"/>
              </a:rPr>
              <a:t>               </a:t>
            </a:r>
            <a:r>
              <a:rPr b="0" lang="pt-BR" sz="1100" spc="-1" strike="noStrike">
                <a:solidFill>
                  <a:srgbClr val="000000"/>
                </a:solidFill>
                <a:latin typeface="Courier New"/>
              </a:rPr>
              <a:t>+N +IK ++</a:t>
            </a:r>
            <a:r>
              <a:rPr b="0" lang="pt-BR" sz="200" spc="-1" strike="noStrike">
                <a:solidFill>
                  <a:srgbClr val="000000"/>
                </a:solidFill>
                <a:latin typeface="Courier New"/>
              </a:rPr>
              <a:t>         </a:t>
            </a:r>
            <a:r>
              <a:rPr b="0" lang="pt-BR" sz="1100" spc="-1" strike="noStrike">
                <a:solidFill>
                  <a:srgbClr val="000000"/>
                </a:solidFill>
                <a:latin typeface="Courier New"/>
              </a:rPr>
              <a:t>++E++PP</a:t>
            </a:r>
            <a:r>
              <a:rPr b="0" lang="pt-BR" sz="200" spc="-1" strike="noStrike">
                <a:solidFill>
                  <a:srgbClr val="000000"/>
                </a:solidFill>
                <a:latin typeface="Courier New"/>
              </a:rPr>
              <a:t>    </a:t>
            </a:r>
            <a:r>
              <a:rPr b="0" lang="pt-BR" sz="1100" spc="-1" strike="noStrike">
                <a:solidFill>
                  <a:srgbClr val="000000"/>
                </a:solidFill>
                <a:latin typeface="Courier New"/>
              </a:rPr>
              <a:t>P</a:t>
            </a:r>
            <a:r>
              <a:rPr b="0" lang="pt-BR" sz="100" spc="-1" strike="noStrike">
                <a:solidFill>
                  <a:srgbClr val="000000"/>
                </a:solidFill>
                <a:latin typeface="Courier New"/>
              </a:rPr>
              <a:t>            </a:t>
            </a:r>
            <a:r>
              <a:rPr b="0" lang="pt-BR" sz="200" spc="-1" strike="noStrike">
                <a:solidFill>
                  <a:srgbClr val="000000"/>
                </a:solidFill>
                <a:latin typeface="Courier New"/>
              </a:rPr>
              <a:t>  </a:t>
            </a:r>
            <a:r>
              <a:rPr b="0" lang="pt-BR" sz="1100" spc="-1" strike="noStrike">
                <a:solidFill>
                  <a:srgbClr val="000000"/>
                </a:solidFill>
                <a:latin typeface="Courier New"/>
              </a:rPr>
              <a:t> +N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ourier New"/>
              </a:rPr>
              <a:t>LBF 0995: 294 EANAQIKETEGARRESVPPTPKFDEN 319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57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7-11T01:00:29Z</dcterms:created>
  <dc:creator>Marija</dc:creator>
  <dc:description/>
  <dc:language>en-US</dc:language>
  <cp:lastModifiedBy>Marija</cp:lastModifiedBy>
  <dcterms:modified xsi:type="dcterms:W3CDTF">2010-08-03T22:44:44Z</dcterms:modified>
  <cp:revision>153</cp:revision>
  <dc:subject/>
  <dc:title>Slide 1</dc:title>
</cp:coreProperties>
</file>